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AA518-EFA3-4E7D-8EAF-D77BADA3AC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77BDB8-4703-4E8B-AE95-E300C261E0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901B3-4E8F-44F6-A166-FC6FC48B1A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023213-C6B6-46C1-874A-418E019F1C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2F950F-5ECC-43B1-849E-58DD990692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0AB6B-824D-4D1E-8D45-6E8AB31106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13CAF-2438-4E81-820A-2D276E882F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792DA-7657-468D-9489-E66AB84826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6627D-0FA5-4DDB-9F03-8EB1B9D11E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E7B8E8-F0F5-4991-976A-BA18A1236C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72D84E-B137-408D-B9AE-14EC465641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F8C4C-1E80-4A51-8020-808CDDB262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2E9549-49DC-4877-8B21-1D2A00C2CDFE}" type="slidenum">
              <a:rPr b="0" lang="da-DK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33360" y="79200"/>
            <a:ext cx="6264360" cy="42055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42920" y="-108000"/>
            <a:ext cx="765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15920" y="4284720"/>
            <a:ext cx="765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041280" y="4789440"/>
            <a:ext cx="747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tient P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258360" y="5735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346200" y="5735520"/>
            <a:ext cx="145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/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257640" y="59230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430800" y="59230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/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098240" y="4789440"/>
            <a:ext cx="466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ath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228200" y="5735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316040" y="57355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358520" y="5735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226400" y="5923080"/>
            <a:ext cx="384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/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027760" y="4789440"/>
            <a:ext cx="50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oth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155560" y="5735520"/>
            <a:ext cx="247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/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154840" y="59230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330520" y="592308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372280" y="59230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"/>
          <p:cNvGrpSpPr/>
          <p:nvPr/>
        </p:nvGrpSpPr>
        <p:grpSpPr>
          <a:xfrm>
            <a:off x="3111480" y="5554800"/>
            <a:ext cx="606600" cy="164880"/>
            <a:chOff x="3111480" y="5554800"/>
            <a:chExt cx="606600" cy="164880"/>
          </a:xfrm>
        </p:grpSpPr>
        <p:sp>
          <p:nvSpPr>
            <p:cNvPr id="60" name=""/>
            <p:cNvSpPr/>
            <p:nvPr/>
          </p:nvSpPr>
          <p:spPr>
            <a:xfrm>
              <a:off x="3111480" y="555480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111480" y="555480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"/>
          <p:cNvSpPr/>
          <p:nvPr/>
        </p:nvSpPr>
        <p:spPr>
          <a:xfrm>
            <a:off x="3111480" y="5554800"/>
            <a:ext cx="606600" cy="164880"/>
          </a:xfrm>
          <a:custGeom>
            <a:avLst/>
            <a:gdLst/>
            <a:ahLst/>
            <a:rect l="l" t="t" r="r" b="b"/>
            <a:pathLst>
              <a:path w="382" h="104">
                <a:moveTo>
                  <a:pt x="382" y="104"/>
                </a:moveTo>
                <a:lnTo>
                  <a:pt x="382" y="0"/>
                </a:lnTo>
                <a:lnTo>
                  <a:pt x="0" y="0"/>
                </a:lnTo>
                <a:lnTo>
                  <a:pt x="382" y="104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"/>
          <p:cNvGrpSpPr/>
          <p:nvPr/>
        </p:nvGrpSpPr>
        <p:grpSpPr>
          <a:xfrm>
            <a:off x="3111480" y="5365800"/>
            <a:ext cx="606600" cy="164880"/>
            <a:chOff x="3111480" y="5365800"/>
            <a:chExt cx="606600" cy="164880"/>
          </a:xfrm>
        </p:grpSpPr>
        <p:sp>
          <p:nvSpPr>
            <p:cNvPr id="64" name=""/>
            <p:cNvSpPr/>
            <p:nvPr/>
          </p:nvSpPr>
          <p:spPr>
            <a:xfrm>
              <a:off x="3111480" y="536580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1d0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111480" y="536580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"/>
          <p:cNvSpPr/>
          <p:nvPr/>
        </p:nvSpPr>
        <p:spPr>
          <a:xfrm>
            <a:off x="3111480" y="5365800"/>
            <a:ext cx="606600" cy="164880"/>
          </a:xfrm>
          <a:custGeom>
            <a:avLst/>
            <a:gdLst/>
            <a:ahLst/>
            <a:rect l="l" t="t" r="r" b="b"/>
            <a:pathLst>
              <a:path w="382" h="104">
                <a:moveTo>
                  <a:pt x="382" y="104"/>
                </a:moveTo>
                <a:lnTo>
                  <a:pt x="382" y="0"/>
                </a:lnTo>
                <a:lnTo>
                  <a:pt x="0" y="0"/>
                </a:lnTo>
                <a:lnTo>
                  <a:pt x="382" y="104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"/>
          <p:cNvGrpSpPr/>
          <p:nvPr/>
        </p:nvGrpSpPr>
        <p:grpSpPr>
          <a:xfrm>
            <a:off x="303120" y="4700520"/>
            <a:ext cx="2225880" cy="569880"/>
            <a:chOff x="303120" y="4700520"/>
            <a:chExt cx="2225880" cy="569880"/>
          </a:xfrm>
        </p:grpSpPr>
        <p:sp>
          <p:nvSpPr>
            <p:cNvPr id="68" name=""/>
            <p:cNvSpPr/>
            <p:nvPr/>
          </p:nvSpPr>
          <p:spPr>
            <a:xfrm>
              <a:off x="303120" y="4700520"/>
              <a:ext cx="2225880" cy="569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03120" y="4700520"/>
              <a:ext cx="2225880" cy="569880"/>
            </a:xfrm>
            <a:prstGeom prst="rect">
              <a:avLst/>
            </a:prstGeom>
            <a:noFill/>
            <a:ln cap="rnd"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"/>
          <p:cNvSpPr/>
          <p:nvPr/>
        </p:nvSpPr>
        <p:spPr>
          <a:xfrm>
            <a:off x="1961280" y="4789440"/>
            <a:ext cx="48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d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451240" y="4789440"/>
            <a:ext cx="51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958760" y="4978440"/>
            <a:ext cx="723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xchan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957680" y="5361120"/>
            <a:ext cx="596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D326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958400" y="5546880"/>
            <a:ext cx="520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G56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265480" y="5735520"/>
            <a:ext cx="51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265480" y="5923080"/>
            <a:ext cx="51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958040" y="6108840"/>
            <a:ext cx="61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M408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957680" y="6296040"/>
            <a:ext cx="563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L160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957680" y="6483240"/>
            <a:ext cx="604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R177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957680" y="6858000"/>
            <a:ext cx="605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G389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958040" y="7045200"/>
            <a:ext cx="61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R264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957680" y="7232760"/>
            <a:ext cx="596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S704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958400" y="6670800"/>
            <a:ext cx="520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G36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956600" y="7419960"/>
            <a:ext cx="657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P1820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957320" y="7607160"/>
            <a:ext cx="698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M1821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958040" y="7794720"/>
            <a:ext cx="61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.V470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5999760" y="4789440"/>
            <a:ext cx="509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bl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5997600" y="4978440"/>
            <a:ext cx="509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siste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6126480" y="5735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.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6345000" y="573552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126480" y="59230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.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6345000" y="5923080"/>
            <a:ext cx="4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" name=""/>
          <p:cNvGrpSpPr/>
          <p:nvPr/>
        </p:nvGrpSpPr>
        <p:grpSpPr>
          <a:xfrm>
            <a:off x="4067280" y="5554800"/>
            <a:ext cx="606240" cy="164880"/>
            <a:chOff x="4067280" y="5554800"/>
            <a:chExt cx="606240" cy="164880"/>
          </a:xfrm>
        </p:grpSpPr>
        <p:sp>
          <p:nvSpPr>
            <p:cNvPr id="94" name=""/>
            <p:cNvSpPr/>
            <p:nvPr/>
          </p:nvSpPr>
          <p:spPr>
            <a:xfrm>
              <a:off x="4067280" y="555480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067280" y="555480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6" name=""/>
          <p:cNvSpPr/>
          <p:nvPr/>
        </p:nvSpPr>
        <p:spPr>
          <a:xfrm>
            <a:off x="4067280" y="5554800"/>
            <a:ext cx="606240" cy="164880"/>
          </a:xfrm>
          <a:custGeom>
            <a:avLst/>
            <a:gdLst/>
            <a:ahLst/>
            <a:rect l="l" t="t" r="r" b="b"/>
            <a:pathLst>
              <a:path w="382" h="104">
                <a:moveTo>
                  <a:pt x="382" y="104"/>
                </a:moveTo>
                <a:lnTo>
                  <a:pt x="382" y="0"/>
                </a:lnTo>
                <a:lnTo>
                  <a:pt x="0" y="0"/>
                </a:lnTo>
                <a:lnTo>
                  <a:pt x="382" y="104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"/>
          <p:cNvGrpSpPr/>
          <p:nvPr/>
        </p:nvGrpSpPr>
        <p:grpSpPr>
          <a:xfrm>
            <a:off x="4067280" y="5365800"/>
            <a:ext cx="606240" cy="164880"/>
            <a:chOff x="4067280" y="5365800"/>
            <a:chExt cx="606240" cy="164880"/>
          </a:xfrm>
        </p:grpSpPr>
        <p:sp>
          <p:nvSpPr>
            <p:cNvPr id="98" name=""/>
            <p:cNvSpPr/>
            <p:nvPr/>
          </p:nvSpPr>
          <p:spPr>
            <a:xfrm>
              <a:off x="4067280" y="536580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067280" y="536580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"/>
          <p:cNvSpPr/>
          <p:nvPr/>
        </p:nvSpPr>
        <p:spPr>
          <a:xfrm>
            <a:off x="4067280" y="5365800"/>
            <a:ext cx="606240" cy="164880"/>
          </a:xfrm>
          <a:custGeom>
            <a:avLst/>
            <a:gdLst/>
            <a:ahLst/>
            <a:rect l="l" t="t" r="r" b="b"/>
            <a:pathLst>
              <a:path w="382" h="104">
                <a:moveTo>
                  <a:pt x="382" y="104"/>
                </a:moveTo>
                <a:lnTo>
                  <a:pt x="382" y="0"/>
                </a:lnTo>
                <a:lnTo>
                  <a:pt x="0" y="0"/>
                </a:lnTo>
                <a:lnTo>
                  <a:pt x="382" y="104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022720" y="5554800"/>
            <a:ext cx="606600" cy="164880"/>
          </a:xfrm>
          <a:custGeom>
            <a:avLst/>
            <a:gdLst/>
            <a:ahLst/>
            <a:rect l="l" t="t" r="r" b="b"/>
            <a:pathLst>
              <a:path w="382" h="104">
                <a:moveTo>
                  <a:pt x="0" y="0"/>
                </a:moveTo>
                <a:lnTo>
                  <a:pt x="0" y="104"/>
                </a:lnTo>
                <a:lnTo>
                  <a:pt x="382" y="104"/>
                </a:lnTo>
                <a:lnTo>
                  <a:pt x="0" y="0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022720" y="5554800"/>
            <a:ext cx="606600" cy="164880"/>
          </a:xfrm>
          <a:custGeom>
            <a:avLst/>
            <a:gdLst/>
            <a:ahLst/>
            <a:rect l="l" t="t" r="r" b="b"/>
            <a:pathLst>
              <a:path w="382" h="104">
                <a:moveTo>
                  <a:pt x="382" y="104"/>
                </a:moveTo>
                <a:lnTo>
                  <a:pt x="382" y="0"/>
                </a:lnTo>
                <a:lnTo>
                  <a:pt x="0" y="0"/>
                </a:lnTo>
                <a:lnTo>
                  <a:pt x="382" y="104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5022720" y="5365800"/>
            <a:ext cx="606600" cy="164880"/>
          </a:xfrm>
          <a:custGeom>
            <a:avLst/>
            <a:gdLst/>
            <a:ahLst/>
            <a:rect l="l" t="t" r="r" b="b"/>
            <a:pathLst>
              <a:path w="382" h="104">
                <a:moveTo>
                  <a:pt x="0" y="0"/>
                </a:moveTo>
                <a:lnTo>
                  <a:pt x="0" y="104"/>
                </a:lnTo>
                <a:lnTo>
                  <a:pt x="382" y="104"/>
                </a:lnTo>
                <a:lnTo>
                  <a:pt x="0" y="0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5022720" y="5365800"/>
            <a:ext cx="606600" cy="164880"/>
          </a:xfrm>
          <a:custGeom>
            <a:avLst/>
            <a:gdLst/>
            <a:ahLst/>
            <a:rect l="l" t="t" r="r" b="b"/>
            <a:pathLst>
              <a:path w="382" h="104">
                <a:moveTo>
                  <a:pt x="382" y="104"/>
                </a:moveTo>
                <a:lnTo>
                  <a:pt x="382" y="0"/>
                </a:lnTo>
                <a:lnTo>
                  <a:pt x="0" y="0"/>
                </a:lnTo>
                <a:lnTo>
                  <a:pt x="382" y="104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5978520" y="5554800"/>
            <a:ext cx="608040" cy="164880"/>
          </a:xfrm>
          <a:custGeom>
            <a:avLst/>
            <a:gdLst/>
            <a:ahLst/>
            <a:rect l="l" t="t" r="r" b="b"/>
            <a:pathLst>
              <a:path w="383" h="104">
                <a:moveTo>
                  <a:pt x="0" y="0"/>
                </a:moveTo>
                <a:lnTo>
                  <a:pt x="0" y="104"/>
                </a:lnTo>
                <a:lnTo>
                  <a:pt x="383" y="104"/>
                </a:lnTo>
                <a:lnTo>
                  <a:pt x="0" y="0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978520" y="5554800"/>
            <a:ext cx="608040" cy="164880"/>
          </a:xfrm>
          <a:custGeom>
            <a:avLst/>
            <a:gdLst/>
            <a:ahLst/>
            <a:rect l="l" t="t" r="r" b="b"/>
            <a:pathLst>
              <a:path w="383" h="104">
                <a:moveTo>
                  <a:pt x="383" y="104"/>
                </a:moveTo>
                <a:lnTo>
                  <a:pt x="383" y="0"/>
                </a:lnTo>
                <a:lnTo>
                  <a:pt x="0" y="0"/>
                </a:lnTo>
                <a:lnTo>
                  <a:pt x="383" y="104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978520" y="5365800"/>
            <a:ext cx="608040" cy="164880"/>
          </a:xfrm>
          <a:custGeom>
            <a:avLst/>
            <a:gdLst/>
            <a:ahLst/>
            <a:rect l="l" t="t" r="r" b="b"/>
            <a:pathLst>
              <a:path w="383" h="104">
                <a:moveTo>
                  <a:pt x="0" y="0"/>
                </a:moveTo>
                <a:lnTo>
                  <a:pt x="0" y="104"/>
                </a:lnTo>
                <a:lnTo>
                  <a:pt x="383" y="104"/>
                </a:lnTo>
                <a:lnTo>
                  <a:pt x="0" y="0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5978520" y="5365800"/>
            <a:ext cx="608040" cy="164880"/>
          </a:xfrm>
          <a:custGeom>
            <a:avLst/>
            <a:gdLst/>
            <a:ahLst/>
            <a:rect l="l" t="t" r="r" b="b"/>
            <a:pathLst>
              <a:path w="383" h="104">
                <a:moveTo>
                  <a:pt x="383" y="104"/>
                </a:moveTo>
                <a:lnTo>
                  <a:pt x="383" y="0"/>
                </a:lnTo>
                <a:lnTo>
                  <a:pt x="0" y="0"/>
                </a:lnTo>
                <a:lnTo>
                  <a:pt x="383" y="104"/>
                </a:lnTo>
                <a:close/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" name=""/>
          <p:cNvGrpSpPr/>
          <p:nvPr/>
        </p:nvGrpSpPr>
        <p:grpSpPr>
          <a:xfrm>
            <a:off x="3092400" y="7061040"/>
            <a:ext cx="3475080" cy="164880"/>
            <a:chOff x="3092400" y="7061040"/>
            <a:chExt cx="3475080" cy="164880"/>
          </a:xfrm>
        </p:grpSpPr>
        <p:grpSp>
          <p:nvGrpSpPr>
            <p:cNvPr id="110" name=""/>
            <p:cNvGrpSpPr/>
            <p:nvPr/>
          </p:nvGrpSpPr>
          <p:grpSpPr>
            <a:xfrm>
              <a:off x="3092400" y="7061040"/>
              <a:ext cx="606600" cy="164880"/>
              <a:chOff x="3092400" y="7061040"/>
              <a:chExt cx="606600" cy="164880"/>
            </a:xfrm>
          </p:grpSpPr>
          <p:sp>
            <p:nvSpPr>
              <p:cNvPr id="111" name=""/>
              <p:cNvSpPr/>
              <p:nvPr/>
            </p:nvSpPr>
            <p:spPr>
              <a:xfrm>
                <a:off x="3092400" y="706104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092400" y="706104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3" name=""/>
            <p:cNvSpPr/>
            <p:nvPr/>
          </p:nvSpPr>
          <p:spPr>
            <a:xfrm>
              <a:off x="3092400" y="706104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4" name=""/>
            <p:cNvGrpSpPr/>
            <p:nvPr/>
          </p:nvGrpSpPr>
          <p:grpSpPr>
            <a:xfrm>
              <a:off x="4067280" y="7061040"/>
              <a:ext cx="606240" cy="164880"/>
              <a:chOff x="4067280" y="7061040"/>
              <a:chExt cx="606240" cy="164880"/>
            </a:xfrm>
          </p:grpSpPr>
          <p:sp>
            <p:nvSpPr>
              <p:cNvPr id="115" name=""/>
              <p:cNvSpPr/>
              <p:nvPr/>
            </p:nvSpPr>
            <p:spPr>
              <a:xfrm>
                <a:off x="4067280" y="7061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4067280" y="7061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7" name=""/>
            <p:cNvGrpSpPr/>
            <p:nvPr/>
          </p:nvGrpSpPr>
          <p:grpSpPr>
            <a:xfrm>
              <a:off x="4067280" y="7061040"/>
              <a:ext cx="606240" cy="164880"/>
              <a:chOff x="4067280" y="7061040"/>
              <a:chExt cx="606240" cy="164880"/>
            </a:xfrm>
          </p:grpSpPr>
          <p:sp>
            <p:nvSpPr>
              <p:cNvPr id="118" name=""/>
              <p:cNvSpPr/>
              <p:nvPr/>
            </p:nvSpPr>
            <p:spPr>
              <a:xfrm>
                <a:off x="4067280" y="7061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4067280" y="7061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0" name=""/>
            <p:cNvSpPr/>
            <p:nvPr/>
          </p:nvSpPr>
          <p:spPr>
            <a:xfrm>
              <a:off x="5022720" y="706104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022720" y="706104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2" name=""/>
            <p:cNvGrpSpPr/>
            <p:nvPr/>
          </p:nvGrpSpPr>
          <p:grpSpPr>
            <a:xfrm>
              <a:off x="5961240" y="7061040"/>
              <a:ext cx="606240" cy="164880"/>
              <a:chOff x="5961240" y="7061040"/>
              <a:chExt cx="606240" cy="164880"/>
            </a:xfrm>
          </p:grpSpPr>
          <p:sp>
            <p:nvSpPr>
              <p:cNvPr id="123" name=""/>
              <p:cNvSpPr/>
              <p:nvPr/>
            </p:nvSpPr>
            <p:spPr>
              <a:xfrm>
                <a:off x="5961240" y="7061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5961240" y="7061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5" name=""/>
            <p:cNvSpPr/>
            <p:nvPr/>
          </p:nvSpPr>
          <p:spPr>
            <a:xfrm>
              <a:off x="5961240" y="706104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6" name=""/>
          <p:cNvGrpSpPr/>
          <p:nvPr/>
        </p:nvGrpSpPr>
        <p:grpSpPr>
          <a:xfrm>
            <a:off x="3092400" y="6872400"/>
            <a:ext cx="3475080" cy="164880"/>
            <a:chOff x="3092400" y="6872400"/>
            <a:chExt cx="3475080" cy="164880"/>
          </a:xfrm>
        </p:grpSpPr>
        <p:grpSp>
          <p:nvGrpSpPr>
            <p:cNvPr id="127" name=""/>
            <p:cNvGrpSpPr/>
            <p:nvPr/>
          </p:nvGrpSpPr>
          <p:grpSpPr>
            <a:xfrm>
              <a:off x="3092400" y="6872400"/>
              <a:ext cx="606600" cy="164880"/>
              <a:chOff x="3092400" y="6872400"/>
              <a:chExt cx="606600" cy="164880"/>
            </a:xfrm>
          </p:grpSpPr>
          <p:sp>
            <p:nvSpPr>
              <p:cNvPr id="128" name=""/>
              <p:cNvSpPr/>
              <p:nvPr/>
            </p:nvSpPr>
            <p:spPr>
              <a:xfrm>
                <a:off x="3092400" y="687240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3092400" y="687240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0" name=""/>
            <p:cNvSpPr/>
            <p:nvPr/>
          </p:nvSpPr>
          <p:spPr>
            <a:xfrm>
              <a:off x="3092400" y="687240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1" name=""/>
            <p:cNvGrpSpPr/>
            <p:nvPr/>
          </p:nvGrpSpPr>
          <p:grpSpPr>
            <a:xfrm>
              <a:off x="4067280" y="6872400"/>
              <a:ext cx="606240" cy="164880"/>
              <a:chOff x="4067280" y="6872400"/>
              <a:chExt cx="606240" cy="164880"/>
            </a:xfrm>
          </p:grpSpPr>
          <p:sp>
            <p:nvSpPr>
              <p:cNvPr id="132" name=""/>
              <p:cNvSpPr/>
              <p:nvPr/>
            </p:nvSpPr>
            <p:spPr>
              <a:xfrm>
                <a:off x="4067280" y="687240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067280" y="687240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4" name=""/>
            <p:cNvSpPr/>
            <p:nvPr/>
          </p:nvSpPr>
          <p:spPr>
            <a:xfrm>
              <a:off x="4067280" y="687240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5022720" y="687240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5022720" y="687240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5961240" y="687240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5961240" y="687240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9" name=""/>
          <p:cNvGrpSpPr/>
          <p:nvPr/>
        </p:nvGrpSpPr>
        <p:grpSpPr>
          <a:xfrm>
            <a:off x="3092400" y="6114960"/>
            <a:ext cx="3475080" cy="165240"/>
            <a:chOff x="3092400" y="6114960"/>
            <a:chExt cx="3475080" cy="165240"/>
          </a:xfrm>
        </p:grpSpPr>
        <p:grpSp>
          <p:nvGrpSpPr>
            <p:cNvPr id="140" name=""/>
            <p:cNvGrpSpPr/>
            <p:nvPr/>
          </p:nvGrpSpPr>
          <p:grpSpPr>
            <a:xfrm>
              <a:off x="3092400" y="6114960"/>
              <a:ext cx="606600" cy="165240"/>
              <a:chOff x="3092400" y="6114960"/>
              <a:chExt cx="606600" cy="165240"/>
            </a:xfrm>
          </p:grpSpPr>
          <p:sp>
            <p:nvSpPr>
              <p:cNvPr id="141" name=""/>
              <p:cNvSpPr/>
              <p:nvPr/>
            </p:nvSpPr>
            <p:spPr>
              <a:xfrm>
                <a:off x="3092400" y="6114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092400" y="6114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3" name=""/>
            <p:cNvGrpSpPr/>
            <p:nvPr/>
          </p:nvGrpSpPr>
          <p:grpSpPr>
            <a:xfrm>
              <a:off x="3092400" y="6114960"/>
              <a:ext cx="606600" cy="165240"/>
              <a:chOff x="3092400" y="6114960"/>
              <a:chExt cx="606600" cy="165240"/>
            </a:xfrm>
          </p:grpSpPr>
          <p:sp>
            <p:nvSpPr>
              <p:cNvPr id="144" name=""/>
              <p:cNvSpPr/>
              <p:nvPr/>
            </p:nvSpPr>
            <p:spPr>
              <a:xfrm>
                <a:off x="3092400" y="6114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092400" y="6114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6" name=""/>
            <p:cNvGrpSpPr/>
            <p:nvPr/>
          </p:nvGrpSpPr>
          <p:grpSpPr>
            <a:xfrm>
              <a:off x="4067280" y="6114960"/>
              <a:ext cx="606240" cy="165240"/>
              <a:chOff x="4067280" y="6114960"/>
              <a:chExt cx="606240" cy="165240"/>
            </a:xfrm>
          </p:grpSpPr>
          <p:sp>
            <p:nvSpPr>
              <p:cNvPr id="147" name=""/>
              <p:cNvSpPr/>
              <p:nvPr/>
            </p:nvSpPr>
            <p:spPr>
              <a:xfrm>
                <a:off x="4067280" y="6114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41d0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4067280" y="6114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9" name=""/>
            <p:cNvSpPr/>
            <p:nvPr/>
          </p:nvSpPr>
          <p:spPr>
            <a:xfrm>
              <a:off x="4067280" y="6114960"/>
              <a:ext cx="60624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0" name=""/>
            <p:cNvGrpSpPr/>
            <p:nvPr/>
          </p:nvGrpSpPr>
          <p:grpSpPr>
            <a:xfrm>
              <a:off x="5022720" y="6114960"/>
              <a:ext cx="606600" cy="165240"/>
              <a:chOff x="5022720" y="6114960"/>
              <a:chExt cx="606600" cy="165240"/>
            </a:xfrm>
          </p:grpSpPr>
          <p:sp>
            <p:nvSpPr>
              <p:cNvPr id="151" name=""/>
              <p:cNvSpPr/>
              <p:nvPr/>
            </p:nvSpPr>
            <p:spPr>
              <a:xfrm>
                <a:off x="5022720" y="6114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5022720" y="6114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3" name=""/>
            <p:cNvGrpSpPr/>
            <p:nvPr/>
          </p:nvGrpSpPr>
          <p:grpSpPr>
            <a:xfrm>
              <a:off x="5022720" y="6114960"/>
              <a:ext cx="606600" cy="165240"/>
              <a:chOff x="5022720" y="6114960"/>
              <a:chExt cx="606600" cy="165240"/>
            </a:xfrm>
          </p:grpSpPr>
          <p:sp>
            <p:nvSpPr>
              <p:cNvPr id="154" name=""/>
              <p:cNvSpPr/>
              <p:nvPr/>
            </p:nvSpPr>
            <p:spPr>
              <a:xfrm>
                <a:off x="5022720" y="6114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5022720" y="6114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6" name=""/>
            <p:cNvGrpSpPr/>
            <p:nvPr/>
          </p:nvGrpSpPr>
          <p:grpSpPr>
            <a:xfrm>
              <a:off x="5961240" y="6114960"/>
              <a:ext cx="606240" cy="165240"/>
              <a:chOff x="5961240" y="6114960"/>
              <a:chExt cx="606240" cy="165240"/>
            </a:xfrm>
          </p:grpSpPr>
          <p:sp>
            <p:nvSpPr>
              <p:cNvPr id="157" name=""/>
              <p:cNvSpPr/>
              <p:nvPr/>
            </p:nvSpPr>
            <p:spPr>
              <a:xfrm>
                <a:off x="5961240" y="6114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5961240" y="6114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9" name=""/>
            <p:cNvGrpSpPr/>
            <p:nvPr/>
          </p:nvGrpSpPr>
          <p:grpSpPr>
            <a:xfrm>
              <a:off x="5961240" y="6114960"/>
              <a:ext cx="606240" cy="165240"/>
              <a:chOff x="5961240" y="6114960"/>
              <a:chExt cx="606240" cy="165240"/>
            </a:xfrm>
          </p:grpSpPr>
          <p:sp>
            <p:nvSpPr>
              <p:cNvPr id="160" name=""/>
              <p:cNvSpPr/>
              <p:nvPr/>
            </p:nvSpPr>
            <p:spPr>
              <a:xfrm>
                <a:off x="5961240" y="6114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5961240" y="6114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2" name=""/>
          <p:cNvGrpSpPr/>
          <p:nvPr/>
        </p:nvGrpSpPr>
        <p:grpSpPr>
          <a:xfrm>
            <a:off x="3092400" y="7250040"/>
            <a:ext cx="3475080" cy="165240"/>
            <a:chOff x="3092400" y="7250040"/>
            <a:chExt cx="3475080" cy="165240"/>
          </a:xfrm>
        </p:grpSpPr>
        <p:grpSp>
          <p:nvGrpSpPr>
            <p:cNvPr id="163" name=""/>
            <p:cNvGrpSpPr/>
            <p:nvPr/>
          </p:nvGrpSpPr>
          <p:grpSpPr>
            <a:xfrm>
              <a:off x="3092400" y="7250040"/>
              <a:ext cx="606600" cy="164880"/>
              <a:chOff x="3092400" y="7250040"/>
              <a:chExt cx="606600" cy="164880"/>
            </a:xfrm>
          </p:grpSpPr>
          <p:sp>
            <p:nvSpPr>
              <p:cNvPr id="164" name=""/>
              <p:cNvSpPr/>
              <p:nvPr/>
            </p:nvSpPr>
            <p:spPr>
              <a:xfrm>
                <a:off x="3092400" y="725004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3092400" y="725004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6" name=""/>
            <p:cNvSpPr/>
            <p:nvPr/>
          </p:nvSpPr>
          <p:spPr>
            <a:xfrm>
              <a:off x="3092400" y="7250040"/>
              <a:ext cx="60660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7" name=""/>
            <p:cNvGrpSpPr/>
            <p:nvPr/>
          </p:nvGrpSpPr>
          <p:grpSpPr>
            <a:xfrm>
              <a:off x="4067280" y="7250040"/>
              <a:ext cx="606240" cy="164880"/>
              <a:chOff x="4067280" y="7250040"/>
              <a:chExt cx="606240" cy="164880"/>
            </a:xfrm>
          </p:grpSpPr>
          <p:sp>
            <p:nvSpPr>
              <p:cNvPr id="168" name=""/>
              <p:cNvSpPr/>
              <p:nvPr/>
            </p:nvSpPr>
            <p:spPr>
              <a:xfrm>
                <a:off x="4067280" y="7250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4067280" y="7250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0" name=""/>
            <p:cNvSpPr/>
            <p:nvPr/>
          </p:nvSpPr>
          <p:spPr>
            <a:xfrm>
              <a:off x="4067280" y="7250040"/>
              <a:ext cx="60624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022720" y="7250040"/>
              <a:ext cx="60660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022720" y="7250040"/>
              <a:ext cx="60660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961240" y="7250040"/>
              <a:ext cx="60624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961240" y="7250040"/>
              <a:ext cx="60624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5" name=""/>
          <p:cNvGrpSpPr/>
          <p:nvPr/>
        </p:nvGrpSpPr>
        <p:grpSpPr>
          <a:xfrm>
            <a:off x="3092400" y="6681960"/>
            <a:ext cx="3475080" cy="166680"/>
            <a:chOff x="3092400" y="6681960"/>
            <a:chExt cx="3475080" cy="166680"/>
          </a:xfrm>
        </p:grpSpPr>
        <p:grpSp>
          <p:nvGrpSpPr>
            <p:cNvPr id="176" name=""/>
            <p:cNvGrpSpPr/>
            <p:nvPr/>
          </p:nvGrpSpPr>
          <p:grpSpPr>
            <a:xfrm>
              <a:off x="3092400" y="6681960"/>
              <a:ext cx="606600" cy="166680"/>
              <a:chOff x="3092400" y="6681960"/>
              <a:chExt cx="606600" cy="166680"/>
            </a:xfrm>
          </p:grpSpPr>
          <p:sp>
            <p:nvSpPr>
              <p:cNvPr id="177" name=""/>
              <p:cNvSpPr/>
              <p:nvPr/>
            </p:nvSpPr>
            <p:spPr>
              <a:xfrm>
                <a:off x="3092400" y="6681960"/>
                <a:ext cx="606600" cy="166680"/>
              </a:xfrm>
              <a:custGeom>
                <a:avLst/>
                <a:gdLst/>
                <a:ahLst/>
                <a:rect l="l" t="t" r="r" b="b"/>
                <a:pathLst>
                  <a:path w="38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382" y="10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41d0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3092400" y="6681960"/>
                <a:ext cx="606600" cy="166680"/>
              </a:xfrm>
              <a:custGeom>
                <a:avLst/>
                <a:gdLst/>
                <a:ahLst/>
                <a:rect l="l" t="t" r="r" b="b"/>
                <a:pathLst>
                  <a:path w="38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382" y="105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9" name=""/>
            <p:cNvSpPr/>
            <p:nvPr/>
          </p:nvSpPr>
          <p:spPr>
            <a:xfrm>
              <a:off x="3092400" y="6681960"/>
              <a:ext cx="606600" cy="166680"/>
            </a:xfrm>
            <a:custGeom>
              <a:avLst/>
              <a:gdLst/>
              <a:ahLst/>
              <a:rect l="l" t="t" r="r" b="b"/>
              <a:pathLst>
                <a:path w="382" h="105">
                  <a:moveTo>
                    <a:pt x="382" y="105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5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0" name=""/>
            <p:cNvGrpSpPr/>
            <p:nvPr/>
          </p:nvGrpSpPr>
          <p:grpSpPr>
            <a:xfrm>
              <a:off x="4067280" y="6681960"/>
              <a:ext cx="606240" cy="166680"/>
              <a:chOff x="4067280" y="6681960"/>
              <a:chExt cx="606240" cy="166680"/>
            </a:xfrm>
          </p:grpSpPr>
          <p:sp>
            <p:nvSpPr>
              <p:cNvPr id="181" name=""/>
              <p:cNvSpPr/>
              <p:nvPr/>
            </p:nvSpPr>
            <p:spPr>
              <a:xfrm>
                <a:off x="4067280" y="6681960"/>
                <a:ext cx="606240" cy="166680"/>
              </a:xfrm>
              <a:custGeom>
                <a:avLst/>
                <a:gdLst/>
                <a:ahLst/>
                <a:rect l="l" t="t" r="r" b="b"/>
                <a:pathLst>
                  <a:path w="38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382" y="10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4067280" y="6681960"/>
                <a:ext cx="606240" cy="166680"/>
              </a:xfrm>
              <a:custGeom>
                <a:avLst/>
                <a:gdLst/>
                <a:ahLst/>
                <a:rect l="l" t="t" r="r" b="b"/>
                <a:pathLst>
                  <a:path w="38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382" y="105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3" name=""/>
            <p:cNvSpPr/>
            <p:nvPr/>
          </p:nvSpPr>
          <p:spPr>
            <a:xfrm>
              <a:off x="4067280" y="6681960"/>
              <a:ext cx="606240" cy="166680"/>
            </a:xfrm>
            <a:custGeom>
              <a:avLst/>
              <a:gdLst/>
              <a:ahLst/>
              <a:rect l="l" t="t" r="r" b="b"/>
              <a:pathLst>
                <a:path w="382" h="105">
                  <a:moveTo>
                    <a:pt x="382" y="105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5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5022720" y="6681960"/>
              <a:ext cx="606600" cy="166680"/>
            </a:xfrm>
            <a:custGeom>
              <a:avLst/>
              <a:gdLst/>
              <a:ahLst/>
              <a:rect l="l" t="t" r="r" b="b"/>
              <a:pathLst>
                <a:path w="382" h="105">
                  <a:moveTo>
                    <a:pt x="0" y="0"/>
                  </a:moveTo>
                  <a:lnTo>
                    <a:pt x="0" y="105"/>
                  </a:lnTo>
                  <a:lnTo>
                    <a:pt x="382" y="105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5022720" y="6681960"/>
              <a:ext cx="606600" cy="166680"/>
            </a:xfrm>
            <a:custGeom>
              <a:avLst/>
              <a:gdLst/>
              <a:ahLst/>
              <a:rect l="l" t="t" r="r" b="b"/>
              <a:pathLst>
                <a:path w="382" h="105">
                  <a:moveTo>
                    <a:pt x="382" y="105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5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6" name=""/>
            <p:cNvGrpSpPr/>
            <p:nvPr/>
          </p:nvGrpSpPr>
          <p:grpSpPr>
            <a:xfrm>
              <a:off x="5961240" y="6681960"/>
              <a:ext cx="606240" cy="166680"/>
              <a:chOff x="5961240" y="6681960"/>
              <a:chExt cx="606240" cy="166680"/>
            </a:xfrm>
          </p:grpSpPr>
          <p:sp>
            <p:nvSpPr>
              <p:cNvPr id="187" name=""/>
              <p:cNvSpPr/>
              <p:nvPr/>
            </p:nvSpPr>
            <p:spPr>
              <a:xfrm>
                <a:off x="5961240" y="6681960"/>
                <a:ext cx="606240" cy="166680"/>
              </a:xfrm>
              <a:custGeom>
                <a:avLst/>
                <a:gdLst/>
                <a:ahLst/>
                <a:rect l="l" t="t" r="r" b="b"/>
                <a:pathLst>
                  <a:path w="38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382" y="10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41d0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5961240" y="6681960"/>
                <a:ext cx="606240" cy="166680"/>
              </a:xfrm>
              <a:custGeom>
                <a:avLst/>
                <a:gdLst/>
                <a:ahLst/>
                <a:rect l="l" t="t" r="r" b="b"/>
                <a:pathLst>
                  <a:path w="382" h="105">
                    <a:moveTo>
                      <a:pt x="0" y="0"/>
                    </a:moveTo>
                    <a:lnTo>
                      <a:pt x="0" y="105"/>
                    </a:lnTo>
                    <a:lnTo>
                      <a:pt x="382" y="105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9" name=""/>
            <p:cNvSpPr/>
            <p:nvPr/>
          </p:nvSpPr>
          <p:spPr>
            <a:xfrm>
              <a:off x="5961240" y="6681960"/>
              <a:ext cx="606240" cy="166680"/>
            </a:xfrm>
            <a:custGeom>
              <a:avLst/>
              <a:gdLst/>
              <a:ahLst/>
              <a:rect l="l" t="t" r="r" b="b"/>
              <a:pathLst>
                <a:path w="382" h="105">
                  <a:moveTo>
                    <a:pt x="382" y="105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5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0" name=""/>
          <p:cNvGrpSpPr/>
          <p:nvPr/>
        </p:nvGrpSpPr>
        <p:grpSpPr>
          <a:xfrm>
            <a:off x="3092400" y="7439040"/>
            <a:ext cx="3475080" cy="165240"/>
            <a:chOff x="3092400" y="7439040"/>
            <a:chExt cx="3475080" cy="165240"/>
          </a:xfrm>
        </p:grpSpPr>
        <p:grpSp>
          <p:nvGrpSpPr>
            <p:cNvPr id="191" name=""/>
            <p:cNvGrpSpPr/>
            <p:nvPr/>
          </p:nvGrpSpPr>
          <p:grpSpPr>
            <a:xfrm>
              <a:off x="3092400" y="7439040"/>
              <a:ext cx="606600" cy="165240"/>
              <a:chOff x="3092400" y="7439040"/>
              <a:chExt cx="606600" cy="165240"/>
            </a:xfrm>
          </p:grpSpPr>
          <p:sp>
            <p:nvSpPr>
              <p:cNvPr id="192" name=""/>
              <p:cNvSpPr/>
              <p:nvPr/>
            </p:nvSpPr>
            <p:spPr>
              <a:xfrm>
                <a:off x="3092400" y="743904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3092400" y="743904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4" name=""/>
            <p:cNvSpPr/>
            <p:nvPr/>
          </p:nvSpPr>
          <p:spPr>
            <a:xfrm>
              <a:off x="3092400" y="7439040"/>
              <a:ext cx="60660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5" name=""/>
            <p:cNvGrpSpPr/>
            <p:nvPr/>
          </p:nvGrpSpPr>
          <p:grpSpPr>
            <a:xfrm>
              <a:off x="4067280" y="7439040"/>
              <a:ext cx="606240" cy="165240"/>
              <a:chOff x="4067280" y="7439040"/>
              <a:chExt cx="606240" cy="165240"/>
            </a:xfrm>
          </p:grpSpPr>
          <p:sp>
            <p:nvSpPr>
              <p:cNvPr id="196" name=""/>
              <p:cNvSpPr/>
              <p:nvPr/>
            </p:nvSpPr>
            <p:spPr>
              <a:xfrm>
                <a:off x="4067280" y="743904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4067280" y="743904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8" name=""/>
            <p:cNvGrpSpPr/>
            <p:nvPr/>
          </p:nvGrpSpPr>
          <p:grpSpPr>
            <a:xfrm>
              <a:off x="4067280" y="7439040"/>
              <a:ext cx="606240" cy="165240"/>
              <a:chOff x="4067280" y="7439040"/>
              <a:chExt cx="606240" cy="165240"/>
            </a:xfrm>
          </p:grpSpPr>
          <p:sp>
            <p:nvSpPr>
              <p:cNvPr id="199" name=""/>
              <p:cNvSpPr/>
              <p:nvPr/>
            </p:nvSpPr>
            <p:spPr>
              <a:xfrm>
                <a:off x="4067280" y="743904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4067280" y="743904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1" name=""/>
            <p:cNvGrpSpPr/>
            <p:nvPr/>
          </p:nvGrpSpPr>
          <p:grpSpPr>
            <a:xfrm>
              <a:off x="5022720" y="7439040"/>
              <a:ext cx="606600" cy="165240"/>
              <a:chOff x="5022720" y="7439040"/>
              <a:chExt cx="606600" cy="165240"/>
            </a:xfrm>
          </p:grpSpPr>
          <p:sp>
            <p:nvSpPr>
              <p:cNvPr id="202" name=""/>
              <p:cNvSpPr/>
              <p:nvPr/>
            </p:nvSpPr>
            <p:spPr>
              <a:xfrm>
                <a:off x="5022720" y="743904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5022720" y="743904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4" name=""/>
            <p:cNvSpPr/>
            <p:nvPr/>
          </p:nvSpPr>
          <p:spPr>
            <a:xfrm>
              <a:off x="5022720" y="7439040"/>
              <a:ext cx="60660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5" name=""/>
            <p:cNvGrpSpPr/>
            <p:nvPr/>
          </p:nvGrpSpPr>
          <p:grpSpPr>
            <a:xfrm>
              <a:off x="5961240" y="7439040"/>
              <a:ext cx="606240" cy="165240"/>
              <a:chOff x="5961240" y="7439040"/>
              <a:chExt cx="606240" cy="165240"/>
            </a:xfrm>
          </p:grpSpPr>
          <p:sp>
            <p:nvSpPr>
              <p:cNvPr id="206" name=""/>
              <p:cNvSpPr/>
              <p:nvPr/>
            </p:nvSpPr>
            <p:spPr>
              <a:xfrm>
                <a:off x="5961240" y="743904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961240" y="743904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8" name=""/>
            <p:cNvGrpSpPr/>
            <p:nvPr/>
          </p:nvGrpSpPr>
          <p:grpSpPr>
            <a:xfrm>
              <a:off x="5961240" y="7439040"/>
              <a:ext cx="606240" cy="165240"/>
              <a:chOff x="5961240" y="7439040"/>
              <a:chExt cx="606240" cy="165240"/>
            </a:xfrm>
          </p:grpSpPr>
          <p:sp>
            <p:nvSpPr>
              <p:cNvPr id="209" name=""/>
              <p:cNvSpPr/>
              <p:nvPr/>
            </p:nvSpPr>
            <p:spPr>
              <a:xfrm>
                <a:off x="5961240" y="743904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5961240" y="743904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11" name=""/>
          <p:cNvSpPr/>
          <p:nvPr/>
        </p:nvSpPr>
        <p:spPr>
          <a:xfrm>
            <a:off x="3216600" y="84628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3302640" y="86518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4213440" y="84758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4299840" y="8663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5244120" y="84758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5244120" y="8663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6239160" y="84758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6325200" y="8663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462600" y="4789440"/>
            <a:ext cx="383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461520" y="5356080"/>
            <a:ext cx="713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ff0000"/>
                </a:solidFill>
                <a:latin typeface="Arial"/>
              </a:rPr>
              <a:t>SLC29A4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1189440" y="5353200"/>
            <a:ext cx="532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(PMA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461160" y="5543640"/>
            <a:ext cx="61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SLC6A4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085760" y="5546880"/>
            <a:ext cx="50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(SER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680040" y="57326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768240" y="5732640"/>
            <a:ext cx="51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818280" y="5732640"/>
            <a:ext cx="593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HTTLP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679320" y="5919840"/>
            <a:ext cx="81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STin2VN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460440" y="6105600"/>
            <a:ext cx="655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SLC22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460440" y="6294600"/>
            <a:ext cx="655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SLC22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462600" y="6478560"/>
            <a:ext cx="50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ff0000"/>
                </a:solidFill>
                <a:latin typeface="Arial"/>
              </a:rPr>
              <a:t>HTR3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462600" y="6858000"/>
            <a:ext cx="53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YFI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462240" y="7045200"/>
            <a:ext cx="45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IS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462240" y="7232760"/>
            <a:ext cx="45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IS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462600" y="6672240"/>
            <a:ext cx="50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HTR3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462240" y="7419960"/>
            <a:ext cx="74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ACNA1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462240" y="7607160"/>
            <a:ext cx="74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ACNA1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463680" y="7794720"/>
            <a:ext cx="406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F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457200" y="5262480"/>
            <a:ext cx="6135840" cy="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28680" y="8275680"/>
            <a:ext cx="1960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umulative genetic burde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30120" y="8435880"/>
            <a:ext cx="1998720" cy="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2328840" y="8275680"/>
            <a:ext cx="51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329760" y="84628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“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407880" y="8462880"/>
            <a:ext cx="1078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otal gene hi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1506240" y="84628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”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29760" y="86518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“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407880" y="8651880"/>
            <a:ext cx="1425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Serotonin gene hi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1860120" y="86518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</a:rPr>
              <a:t>”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8" name=""/>
          <p:cNvGrpSpPr/>
          <p:nvPr/>
        </p:nvGrpSpPr>
        <p:grpSpPr>
          <a:xfrm>
            <a:off x="3092400" y="7816680"/>
            <a:ext cx="3475080" cy="165240"/>
            <a:chOff x="3092400" y="7816680"/>
            <a:chExt cx="3475080" cy="165240"/>
          </a:xfrm>
        </p:grpSpPr>
        <p:sp>
          <p:nvSpPr>
            <p:cNvPr id="249" name=""/>
            <p:cNvSpPr/>
            <p:nvPr/>
          </p:nvSpPr>
          <p:spPr>
            <a:xfrm>
              <a:off x="3092400" y="7816680"/>
              <a:ext cx="60660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4067280" y="7816680"/>
              <a:ext cx="60624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1" name=""/>
            <p:cNvGrpSpPr/>
            <p:nvPr/>
          </p:nvGrpSpPr>
          <p:grpSpPr>
            <a:xfrm>
              <a:off x="5022720" y="7816680"/>
              <a:ext cx="606600" cy="165240"/>
              <a:chOff x="5022720" y="7816680"/>
              <a:chExt cx="606600" cy="165240"/>
            </a:xfrm>
          </p:grpSpPr>
          <p:sp>
            <p:nvSpPr>
              <p:cNvPr id="252" name=""/>
              <p:cNvSpPr/>
              <p:nvPr/>
            </p:nvSpPr>
            <p:spPr>
              <a:xfrm>
                <a:off x="5022720" y="781668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5022720" y="781668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4" name=""/>
            <p:cNvSpPr/>
            <p:nvPr/>
          </p:nvSpPr>
          <p:spPr>
            <a:xfrm>
              <a:off x="5022720" y="7816680"/>
              <a:ext cx="60660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5961240" y="7816680"/>
              <a:ext cx="60624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0" y="0"/>
                  </a:moveTo>
                  <a:lnTo>
                    <a:pt x="0" y="104"/>
                  </a:lnTo>
                  <a:lnTo>
                    <a:pt x="382" y="104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5961240" y="7816680"/>
              <a:ext cx="606240" cy="16524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7" name=""/>
            <p:cNvGrpSpPr/>
            <p:nvPr/>
          </p:nvGrpSpPr>
          <p:grpSpPr>
            <a:xfrm>
              <a:off x="4067280" y="7816680"/>
              <a:ext cx="606240" cy="165240"/>
              <a:chOff x="4067280" y="7816680"/>
              <a:chExt cx="606240" cy="165240"/>
            </a:xfrm>
          </p:grpSpPr>
          <p:sp>
            <p:nvSpPr>
              <p:cNvPr id="258" name=""/>
              <p:cNvSpPr/>
              <p:nvPr/>
            </p:nvSpPr>
            <p:spPr>
              <a:xfrm>
                <a:off x="4067280" y="781668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4067280" y="781668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0" name=""/>
            <p:cNvGrpSpPr/>
            <p:nvPr/>
          </p:nvGrpSpPr>
          <p:grpSpPr>
            <a:xfrm>
              <a:off x="3092400" y="7816680"/>
              <a:ext cx="606600" cy="165240"/>
              <a:chOff x="3092400" y="7816680"/>
              <a:chExt cx="606600" cy="165240"/>
            </a:xfrm>
          </p:grpSpPr>
          <p:sp>
            <p:nvSpPr>
              <p:cNvPr id="261" name=""/>
              <p:cNvSpPr/>
              <p:nvPr/>
            </p:nvSpPr>
            <p:spPr>
              <a:xfrm>
                <a:off x="3092400" y="781668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3092400" y="781668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63" name=""/>
          <p:cNvGrpSpPr/>
          <p:nvPr/>
        </p:nvGrpSpPr>
        <p:grpSpPr>
          <a:xfrm>
            <a:off x="3092400" y="6492960"/>
            <a:ext cx="3475080" cy="164880"/>
            <a:chOff x="3092400" y="6492960"/>
            <a:chExt cx="3475080" cy="164880"/>
          </a:xfrm>
        </p:grpSpPr>
        <p:grpSp>
          <p:nvGrpSpPr>
            <p:cNvPr id="264" name=""/>
            <p:cNvGrpSpPr/>
            <p:nvPr/>
          </p:nvGrpSpPr>
          <p:grpSpPr>
            <a:xfrm>
              <a:off x="4067280" y="6492960"/>
              <a:ext cx="606240" cy="164880"/>
              <a:chOff x="4067280" y="6492960"/>
              <a:chExt cx="606240" cy="164880"/>
            </a:xfrm>
          </p:grpSpPr>
          <p:sp>
            <p:nvSpPr>
              <p:cNvPr id="265" name=""/>
              <p:cNvSpPr/>
              <p:nvPr/>
            </p:nvSpPr>
            <p:spPr>
              <a:xfrm>
                <a:off x="4067280" y="649296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4067280" y="649296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67" name=""/>
            <p:cNvSpPr/>
            <p:nvPr/>
          </p:nvSpPr>
          <p:spPr>
            <a:xfrm>
              <a:off x="4067280" y="649296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8" name=""/>
            <p:cNvGrpSpPr/>
            <p:nvPr/>
          </p:nvGrpSpPr>
          <p:grpSpPr>
            <a:xfrm>
              <a:off x="5022720" y="6492960"/>
              <a:ext cx="606600" cy="164880"/>
              <a:chOff x="5022720" y="6492960"/>
              <a:chExt cx="606600" cy="164880"/>
            </a:xfrm>
          </p:grpSpPr>
          <p:sp>
            <p:nvSpPr>
              <p:cNvPr id="269" name=""/>
              <p:cNvSpPr/>
              <p:nvPr/>
            </p:nvSpPr>
            <p:spPr>
              <a:xfrm>
                <a:off x="5022720" y="649296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41d0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5022720" y="649296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71" name=""/>
            <p:cNvSpPr/>
            <p:nvPr/>
          </p:nvSpPr>
          <p:spPr>
            <a:xfrm>
              <a:off x="5022720" y="6492960"/>
              <a:ext cx="60660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72" name=""/>
            <p:cNvGrpSpPr/>
            <p:nvPr/>
          </p:nvGrpSpPr>
          <p:grpSpPr>
            <a:xfrm>
              <a:off x="5961240" y="6492960"/>
              <a:ext cx="606240" cy="164880"/>
              <a:chOff x="5961240" y="6492960"/>
              <a:chExt cx="606240" cy="164880"/>
            </a:xfrm>
          </p:grpSpPr>
          <p:sp>
            <p:nvSpPr>
              <p:cNvPr id="273" name=""/>
              <p:cNvSpPr/>
              <p:nvPr/>
            </p:nvSpPr>
            <p:spPr>
              <a:xfrm>
                <a:off x="5961240" y="649296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5961240" y="649296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75" name=""/>
            <p:cNvSpPr/>
            <p:nvPr/>
          </p:nvSpPr>
          <p:spPr>
            <a:xfrm>
              <a:off x="5961240" y="6492960"/>
              <a:ext cx="606240" cy="164880"/>
            </a:xfrm>
            <a:custGeom>
              <a:avLst/>
              <a:gdLst/>
              <a:ahLst/>
              <a:rect l="l" t="t" r="r" b="b"/>
              <a:pathLst>
                <a:path w="382" h="104">
                  <a:moveTo>
                    <a:pt x="382" y="104"/>
                  </a:moveTo>
                  <a:lnTo>
                    <a:pt x="382" y="0"/>
                  </a:lnTo>
                  <a:lnTo>
                    <a:pt x="0" y="0"/>
                  </a:lnTo>
                  <a:lnTo>
                    <a:pt x="382" y="104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76" name=""/>
            <p:cNvGrpSpPr/>
            <p:nvPr/>
          </p:nvGrpSpPr>
          <p:grpSpPr>
            <a:xfrm>
              <a:off x="3092400" y="6492960"/>
              <a:ext cx="606600" cy="164880"/>
              <a:chOff x="3092400" y="6492960"/>
              <a:chExt cx="606600" cy="164880"/>
            </a:xfrm>
          </p:grpSpPr>
          <p:sp>
            <p:nvSpPr>
              <p:cNvPr id="277" name=""/>
              <p:cNvSpPr/>
              <p:nvPr/>
            </p:nvSpPr>
            <p:spPr>
              <a:xfrm>
                <a:off x="3092400" y="649296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3092400" y="649296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9" name=""/>
            <p:cNvGrpSpPr/>
            <p:nvPr/>
          </p:nvGrpSpPr>
          <p:grpSpPr>
            <a:xfrm>
              <a:off x="3092400" y="6492960"/>
              <a:ext cx="606600" cy="164880"/>
              <a:chOff x="3092400" y="6492960"/>
              <a:chExt cx="606600" cy="164880"/>
            </a:xfrm>
          </p:grpSpPr>
          <p:sp>
            <p:nvSpPr>
              <p:cNvPr id="280" name=""/>
              <p:cNvSpPr/>
              <p:nvPr/>
            </p:nvSpPr>
            <p:spPr>
              <a:xfrm>
                <a:off x="3092400" y="649296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3092400" y="649296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82" name=""/>
          <p:cNvGrpSpPr/>
          <p:nvPr/>
        </p:nvGrpSpPr>
        <p:grpSpPr>
          <a:xfrm>
            <a:off x="3092400" y="6303960"/>
            <a:ext cx="3475080" cy="165240"/>
            <a:chOff x="3092400" y="6303960"/>
            <a:chExt cx="3475080" cy="165240"/>
          </a:xfrm>
        </p:grpSpPr>
        <p:grpSp>
          <p:nvGrpSpPr>
            <p:cNvPr id="283" name=""/>
            <p:cNvGrpSpPr/>
            <p:nvPr/>
          </p:nvGrpSpPr>
          <p:grpSpPr>
            <a:xfrm>
              <a:off x="3092400" y="6303960"/>
              <a:ext cx="606600" cy="165240"/>
              <a:chOff x="3092400" y="6303960"/>
              <a:chExt cx="606600" cy="165240"/>
            </a:xfrm>
          </p:grpSpPr>
          <p:sp>
            <p:nvSpPr>
              <p:cNvPr id="284" name=""/>
              <p:cNvSpPr/>
              <p:nvPr/>
            </p:nvSpPr>
            <p:spPr>
              <a:xfrm>
                <a:off x="3092400" y="6303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3092400" y="6303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6" name=""/>
            <p:cNvGrpSpPr/>
            <p:nvPr/>
          </p:nvGrpSpPr>
          <p:grpSpPr>
            <a:xfrm>
              <a:off x="3092400" y="6303960"/>
              <a:ext cx="606600" cy="165240"/>
              <a:chOff x="3092400" y="6303960"/>
              <a:chExt cx="606600" cy="165240"/>
            </a:xfrm>
          </p:grpSpPr>
          <p:sp>
            <p:nvSpPr>
              <p:cNvPr id="287" name=""/>
              <p:cNvSpPr/>
              <p:nvPr/>
            </p:nvSpPr>
            <p:spPr>
              <a:xfrm>
                <a:off x="3092400" y="6303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3092400" y="6303960"/>
                <a:ext cx="60660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9" name=""/>
            <p:cNvGrpSpPr/>
            <p:nvPr/>
          </p:nvGrpSpPr>
          <p:grpSpPr>
            <a:xfrm>
              <a:off x="4067280" y="6303960"/>
              <a:ext cx="606240" cy="165240"/>
              <a:chOff x="4067280" y="6303960"/>
              <a:chExt cx="606240" cy="165240"/>
            </a:xfrm>
          </p:grpSpPr>
          <p:sp>
            <p:nvSpPr>
              <p:cNvPr id="290" name=""/>
              <p:cNvSpPr/>
              <p:nvPr/>
            </p:nvSpPr>
            <p:spPr>
              <a:xfrm>
                <a:off x="4067280" y="6303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4067280" y="6303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2" name=""/>
            <p:cNvGrpSpPr/>
            <p:nvPr/>
          </p:nvGrpSpPr>
          <p:grpSpPr>
            <a:xfrm>
              <a:off x="4067280" y="6303960"/>
              <a:ext cx="606240" cy="165240"/>
              <a:chOff x="4067280" y="6303960"/>
              <a:chExt cx="606240" cy="165240"/>
            </a:xfrm>
          </p:grpSpPr>
          <p:sp>
            <p:nvSpPr>
              <p:cNvPr id="293" name=""/>
              <p:cNvSpPr/>
              <p:nvPr/>
            </p:nvSpPr>
            <p:spPr>
              <a:xfrm>
                <a:off x="4067280" y="6303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4067280" y="6303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5" name=""/>
            <p:cNvGrpSpPr/>
            <p:nvPr/>
          </p:nvGrpSpPr>
          <p:grpSpPr>
            <a:xfrm>
              <a:off x="5021280" y="6303960"/>
              <a:ext cx="608040" cy="165240"/>
              <a:chOff x="5021280" y="6303960"/>
              <a:chExt cx="608040" cy="165240"/>
            </a:xfrm>
          </p:grpSpPr>
          <p:sp>
            <p:nvSpPr>
              <p:cNvPr id="296" name=""/>
              <p:cNvSpPr/>
              <p:nvPr/>
            </p:nvSpPr>
            <p:spPr>
              <a:xfrm>
                <a:off x="5021280" y="6303960"/>
                <a:ext cx="608040" cy="165240"/>
              </a:xfrm>
              <a:custGeom>
                <a:avLst/>
                <a:gdLst/>
                <a:ahLst/>
                <a:rect l="l" t="t" r="r" b="b"/>
                <a:pathLst>
                  <a:path w="383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3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5021280" y="6303960"/>
                <a:ext cx="608040" cy="165240"/>
              </a:xfrm>
              <a:custGeom>
                <a:avLst/>
                <a:gdLst/>
                <a:ahLst/>
                <a:rect l="l" t="t" r="r" b="b"/>
                <a:pathLst>
                  <a:path w="383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3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8" name=""/>
            <p:cNvGrpSpPr/>
            <p:nvPr/>
          </p:nvGrpSpPr>
          <p:grpSpPr>
            <a:xfrm>
              <a:off x="5021280" y="6303960"/>
              <a:ext cx="608040" cy="165240"/>
              <a:chOff x="5021280" y="6303960"/>
              <a:chExt cx="608040" cy="165240"/>
            </a:xfrm>
          </p:grpSpPr>
          <p:sp>
            <p:nvSpPr>
              <p:cNvPr id="299" name=""/>
              <p:cNvSpPr/>
              <p:nvPr/>
            </p:nvSpPr>
            <p:spPr>
              <a:xfrm>
                <a:off x="5021280" y="6303960"/>
                <a:ext cx="608040" cy="165240"/>
              </a:xfrm>
              <a:custGeom>
                <a:avLst/>
                <a:gdLst/>
                <a:ahLst/>
                <a:rect l="l" t="t" r="r" b="b"/>
                <a:pathLst>
                  <a:path w="383" h="104">
                    <a:moveTo>
                      <a:pt x="383" y="104"/>
                    </a:moveTo>
                    <a:lnTo>
                      <a:pt x="383" y="0"/>
                    </a:lnTo>
                    <a:lnTo>
                      <a:pt x="0" y="0"/>
                    </a:lnTo>
                    <a:lnTo>
                      <a:pt x="383" y="104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5021280" y="6303960"/>
                <a:ext cx="608040" cy="165240"/>
              </a:xfrm>
              <a:custGeom>
                <a:avLst/>
                <a:gdLst/>
                <a:ahLst/>
                <a:rect l="l" t="t" r="r" b="b"/>
                <a:pathLst>
                  <a:path w="383" h="104">
                    <a:moveTo>
                      <a:pt x="383" y="104"/>
                    </a:moveTo>
                    <a:lnTo>
                      <a:pt x="383" y="0"/>
                    </a:lnTo>
                    <a:lnTo>
                      <a:pt x="0" y="0"/>
                    </a:lnTo>
                    <a:lnTo>
                      <a:pt x="383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1" name=""/>
            <p:cNvGrpSpPr/>
            <p:nvPr/>
          </p:nvGrpSpPr>
          <p:grpSpPr>
            <a:xfrm>
              <a:off x="5961240" y="6303960"/>
              <a:ext cx="606240" cy="165240"/>
              <a:chOff x="5961240" y="6303960"/>
              <a:chExt cx="606240" cy="165240"/>
            </a:xfrm>
          </p:grpSpPr>
          <p:sp>
            <p:nvSpPr>
              <p:cNvPr id="302" name=""/>
              <p:cNvSpPr/>
              <p:nvPr/>
            </p:nvSpPr>
            <p:spPr>
              <a:xfrm>
                <a:off x="5961240" y="6303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5961240" y="6303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4" name=""/>
            <p:cNvGrpSpPr/>
            <p:nvPr/>
          </p:nvGrpSpPr>
          <p:grpSpPr>
            <a:xfrm>
              <a:off x="5961240" y="6303960"/>
              <a:ext cx="606240" cy="165240"/>
              <a:chOff x="5961240" y="6303960"/>
              <a:chExt cx="606240" cy="165240"/>
            </a:xfrm>
          </p:grpSpPr>
          <p:sp>
            <p:nvSpPr>
              <p:cNvPr id="305" name=""/>
              <p:cNvSpPr/>
              <p:nvPr/>
            </p:nvSpPr>
            <p:spPr>
              <a:xfrm>
                <a:off x="5961240" y="6303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5961240" y="6303960"/>
                <a:ext cx="606240" cy="16524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307" name=""/>
          <p:cNvGrpSpPr/>
          <p:nvPr/>
        </p:nvGrpSpPr>
        <p:grpSpPr>
          <a:xfrm>
            <a:off x="3092400" y="7628040"/>
            <a:ext cx="3475080" cy="164880"/>
            <a:chOff x="3092400" y="7628040"/>
            <a:chExt cx="3475080" cy="164880"/>
          </a:xfrm>
        </p:grpSpPr>
        <p:grpSp>
          <p:nvGrpSpPr>
            <p:cNvPr id="308" name=""/>
            <p:cNvGrpSpPr/>
            <p:nvPr/>
          </p:nvGrpSpPr>
          <p:grpSpPr>
            <a:xfrm>
              <a:off x="3092400" y="7628040"/>
              <a:ext cx="606600" cy="164880"/>
              <a:chOff x="3092400" y="7628040"/>
              <a:chExt cx="606600" cy="164880"/>
            </a:xfrm>
          </p:grpSpPr>
          <p:sp>
            <p:nvSpPr>
              <p:cNvPr id="309" name=""/>
              <p:cNvSpPr/>
              <p:nvPr/>
            </p:nvSpPr>
            <p:spPr>
              <a:xfrm>
                <a:off x="3092400" y="762804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3092400" y="762804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1" name=""/>
            <p:cNvGrpSpPr/>
            <p:nvPr/>
          </p:nvGrpSpPr>
          <p:grpSpPr>
            <a:xfrm>
              <a:off x="3092400" y="7628040"/>
              <a:ext cx="606600" cy="164880"/>
              <a:chOff x="3092400" y="7628040"/>
              <a:chExt cx="606600" cy="164880"/>
            </a:xfrm>
          </p:grpSpPr>
          <p:sp>
            <p:nvSpPr>
              <p:cNvPr id="312" name=""/>
              <p:cNvSpPr/>
              <p:nvPr/>
            </p:nvSpPr>
            <p:spPr>
              <a:xfrm>
                <a:off x="3092400" y="762804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3092400" y="7628040"/>
                <a:ext cx="60660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4" name=""/>
            <p:cNvGrpSpPr/>
            <p:nvPr/>
          </p:nvGrpSpPr>
          <p:grpSpPr>
            <a:xfrm>
              <a:off x="4067280" y="7628040"/>
              <a:ext cx="606240" cy="164880"/>
              <a:chOff x="4067280" y="7628040"/>
              <a:chExt cx="606240" cy="164880"/>
            </a:xfrm>
          </p:grpSpPr>
          <p:sp>
            <p:nvSpPr>
              <p:cNvPr id="315" name=""/>
              <p:cNvSpPr/>
              <p:nvPr/>
            </p:nvSpPr>
            <p:spPr>
              <a:xfrm>
                <a:off x="4067280" y="7628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4067280" y="7628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7" name=""/>
            <p:cNvGrpSpPr/>
            <p:nvPr/>
          </p:nvGrpSpPr>
          <p:grpSpPr>
            <a:xfrm>
              <a:off x="4067280" y="7628040"/>
              <a:ext cx="606240" cy="164880"/>
              <a:chOff x="4067280" y="7628040"/>
              <a:chExt cx="606240" cy="164880"/>
            </a:xfrm>
          </p:grpSpPr>
          <p:sp>
            <p:nvSpPr>
              <p:cNvPr id="318" name=""/>
              <p:cNvSpPr/>
              <p:nvPr/>
            </p:nvSpPr>
            <p:spPr>
              <a:xfrm>
                <a:off x="4067280" y="7628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4067280" y="7628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0" name=""/>
            <p:cNvGrpSpPr/>
            <p:nvPr/>
          </p:nvGrpSpPr>
          <p:grpSpPr>
            <a:xfrm>
              <a:off x="5021280" y="7628040"/>
              <a:ext cx="608040" cy="164880"/>
              <a:chOff x="5021280" y="7628040"/>
              <a:chExt cx="608040" cy="164880"/>
            </a:xfrm>
          </p:grpSpPr>
          <p:sp>
            <p:nvSpPr>
              <p:cNvPr id="321" name=""/>
              <p:cNvSpPr/>
              <p:nvPr/>
            </p:nvSpPr>
            <p:spPr>
              <a:xfrm>
                <a:off x="5021280" y="7628040"/>
                <a:ext cx="608040" cy="164880"/>
              </a:xfrm>
              <a:custGeom>
                <a:avLst/>
                <a:gdLst/>
                <a:ahLst/>
                <a:rect l="l" t="t" r="r" b="b"/>
                <a:pathLst>
                  <a:path w="383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3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5021280" y="7628040"/>
                <a:ext cx="608040" cy="164880"/>
              </a:xfrm>
              <a:custGeom>
                <a:avLst/>
                <a:gdLst/>
                <a:ahLst/>
                <a:rect l="l" t="t" r="r" b="b"/>
                <a:pathLst>
                  <a:path w="383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3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3" name=""/>
            <p:cNvGrpSpPr/>
            <p:nvPr/>
          </p:nvGrpSpPr>
          <p:grpSpPr>
            <a:xfrm>
              <a:off x="5021280" y="7628040"/>
              <a:ext cx="608040" cy="164880"/>
              <a:chOff x="5021280" y="7628040"/>
              <a:chExt cx="608040" cy="164880"/>
            </a:xfrm>
          </p:grpSpPr>
          <p:sp>
            <p:nvSpPr>
              <p:cNvPr id="324" name=""/>
              <p:cNvSpPr/>
              <p:nvPr/>
            </p:nvSpPr>
            <p:spPr>
              <a:xfrm>
                <a:off x="5021280" y="7628040"/>
                <a:ext cx="608040" cy="164880"/>
              </a:xfrm>
              <a:custGeom>
                <a:avLst/>
                <a:gdLst/>
                <a:ahLst/>
                <a:rect l="l" t="t" r="r" b="b"/>
                <a:pathLst>
                  <a:path w="383" h="104">
                    <a:moveTo>
                      <a:pt x="383" y="104"/>
                    </a:moveTo>
                    <a:lnTo>
                      <a:pt x="383" y="0"/>
                    </a:lnTo>
                    <a:lnTo>
                      <a:pt x="0" y="0"/>
                    </a:lnTo>
                    <a:lnTo>
                      <a:pt x="383" y="104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5021280" y="7628040"/>
                <a:ext cx="608040" cy="164880"/>
              </a:xfrm>
              <a:custGeom>
                <a:avLst/>
                <a:gdLst/>
                <a:ahLst/>
                <a:rect l="l" t="t" r="r" b="b"/>
                <a:pathLst>
                  <a:path w="383" h="104">
                    <a:moveTo>
                      <a:pt x="383" y="104"/>
                    </a:moveTo>
                    <a:lnTo>
                      <a:pt x="383" y="0"/>
                    </a:lnTo>
                    <a:lnTo>
                      <a:pt x="0" y="0"/>
                    </a:lnTo>
                    <a:lnTo>
                      <a:pt x="383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6" name=""/>
            <p:cNvGrpSpPr/>
            <p:nvPr/>
          </p:nvGrpSpPr>
          <p:grpSpPr>
            <a:xfrm>
              <a:off x="5961240" y="7628040"/>
              <a:ext cx="606240" cy="164880"/>
              <a:chOff x="5961240" y="7628040"/>
              <a:chExt cx="606240" cy="164880"/>
            </a:xfrm>
          </p:grpSpPr>
          <p:sp>
            <p:nvSpPr>
              <p:cNvPr id="327" name=""/>
              <p:cNvSpPr/>
              <p:nvPr/>
            </p:nvSpPr>
            <p:spPr>
              <a:xfrm>
                <a:off x="5961240" y="7628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5961240" y="7628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0" y="0"/>
                    </a:moveTo>
                    <a:lnTo>
                      <a:pt x="0" y="104"/>
                    </a:lnTo>
                    <a:lnTo>
                      <a:pt x="382" y="104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9" name=""/>
            <p:cNvGrpSpPr/>
            <p:nvPr/>
          </p:nvGrpSpPr>
          <p:grpSpPr>
            <a:xfrm>
              <a:off x="5961240" y="7628040"/>
              <a:ext cx="606240" cy="164880"/>
              <a:chOff x="5961240" y="7628040"/>
              <a:chExt cx="606240" cy="164880"/>
            </a:xfrm>
          </p:grpSpPr>
          <p:sp>
            <p:nvSpPr>
              <p:cNvPr id="330" name=""/>
              <p:cNvSpPr/>
              <p:nvPr/>
            </p:nvSpPr>
            <p:spPr>
              <a:xfrm>
                <a:off x="5961240" y="7628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solidFill>
                <a:srgbClr val="96969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5961240" y="7628040"/>
                <a:ext cx="606240" cy="164880"/>
              </a:xfrm>
              <a:custGeom>
                <a:avLst/>
                <a:gdLst/>
                <a:ahLst/>
                <a:rect l="l" t="t" r="r" b="b"/>
                <a:pathLst>
                  <a:path w="382" h="104">
                    <a:moveTo>
                      <a:pt x="382" y="104"/>
                    </a:moveTo>
                    <a:lnTo>
                      <a:pt x="382" y="0"/>
                    </a:lnTo>
                    <a:lnTo>
                      <a:pt x="0" y="0"/>
                    </a:lnTo>
                    <a:lnTo>
                      <a:pt x="382" y="104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32" name=""/>
          <p:cNvSpPr/>
          <p:nvPr/>
        </p:nvSpPr>
        <p:spPr>
          <a:xfrm>
            <a:off x="4548240" y="8929800"/>
            <a:ext cx="232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upplementary Figure S4. Adamsen et al R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01T12:03:28Z</dcterms:created>
  <dc:creator>adamsen</dc:creator>
  <dc:description/>
  <dc:language>en-US</dc:language>
  <cp:lastModifiedBy>thb</cp:lastModifiedBy>
  <dcterms:modified xsi:type="dcterms:W3CDTF">2014-05-11T13:16:26Z</dcterms:modified>
  <cp:revision>13</cp:revision>
  <dc:subject/>
  <dc:title>Slide 1</dc:title>
</cp:coreProperties>
</file>